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8" r:id="rId2"/>
  </p:sldIdLst>
  <p:sldSz cx="9144000" cy="6858000" type="screen4x3"/>
  <p:notesSz cx="7010400" cy="9236075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71" d="100"/>
          <a:sy n="71" d="100"/>
        </p:scale>
        <p:origin x="-1128" y="29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CA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CA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CA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CA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5DB1A-EC1F-46F5-8AC0-6157821C567D}" type="datetimeFigureOut">
              <a:rPr lang="fr-CA" smtClean="0"/>
              <a:pPr/>
              <a:t>2016-04-17</a:t>
            </a:fld>
            <a:endParaRPr lang="fr-CA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CA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4B1814-96AA-4EB2-B482-F4D65E57A1E3}" type="slidenum">
              <a:rPr lang="fr-CA" smtClean="0"/>
              <a:pPr/>
              <a:t>‹#›</a:t>
            </a:fld>
            <a:endParaRPr lang="fr-CA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ZoneTexte 14"/>
          <p:cNvSpPr txBox="1"/>
          <p:nvPr/>
        </p:nvSpPr>
        <p:spPr>
          <a:xfrm>
            <a:off x="6449979" y="2287107"/>
            <a:ext cx="56938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CA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4732</a:t>
            </a:r>
          </a:p>
          <a:p>
            <a:pPr algn="r"/>
            <a:r>
              <a:rPr lang="fr-CA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143</a:t>
            </a:r>
          </a:p>
        </p:txBody>
      </p:sp>
      <p:sp>
        <p:nvSpPr>
          <p:cNvPr id="16" name="ZoneTexte 15"/>
          <p:cNvSpPr txBox="1"/>
          <p:nvPr/>
        </p:nvSpPr>
        <p:spPr>
          <a:xfrm>
            <a:off x="6449979" y="2745334"/>
            <a:ext cx="56938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CA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4792</a:t>
            </a:r>
          </a:p>
          <a:p>
            <a:pPr algn="r"/>
            <a:r>
              <a:rPr lang="fr-CA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83</a:t>
            </a:r>
          </a:p>
        </p:txBody>
      </p:sp>
      <p:sp>
        <p:nvSpPr>
          <p:cNvPr id="17" name="ZoneTexte 16"/>
          <p:cNvSpPr txBox="1"/>
          <p:nvPr/>
        </p:nvSpPr>
        <p:spPr>
          <a:xfrm>
            <a:off x="6449979" y="3198845"/>
            <a:ext cx="569388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algn="r"/>
            <a:r>
              <a:rPr lang="fr-CA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4852</a:t>
            </a:r>
          </a:p>
          <a:p>
            <a:pPr algn="r"/>
            <a:r>
              <a:rPr lang="fr-CA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7044</a:t>
            </a:r>
          </a:p>
        </p:txBody>
      </p:sp>
      <p:sp>
        <p:nvSpPr>
          <p:cNvPr id="37" name="Rectangle 36"/>
          <p:cNvSpPr/>
          <p:nvPr/>
        </p:nvSpPr>
        <p:spPr>
          <a:xfrm>
            <a:off x="4787923" y="2182815"/>
            <a:ext cx="432048" cy="396044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sp>
        <p:nvSpPr>
          <p:cNvPr id="36" name="Rectangle 35"/>
          <p:cNvSpPr/>
          <p:nvPr/>
        </p:nvSpPr>
        <p:spPr>
          <a:xfrm>
            <a:off x="1043506" y="2266994"/>
            <a:ext cx="5688733" cy="38318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0"/>
              </a:spcAft>
            </a:pP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GATTTT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GG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TA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TTTGTCC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GAT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AGTG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CATC</a:t>
            </a:r>
            <a:endParaRPr lang="fr-CA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GATTTT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.....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TA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TTTGTCC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GA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......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CATC</a:t>
            </a:r>
            <a:endParaRPr lang="fr-CA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endParaRPr lang="fr-CA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TCTCAATACT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TCC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 </a:t>
            </a:r>
            <a:endParaRPr lang="fr-CA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TCTCAATACT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TCCT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A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  </a:t>
            </a:r>
            <a:endParaRPr lang="fr-CA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ATTTAAGGC</a:t>
            </a:r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G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CA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T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TC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AG</a:t>
            </a:r>
            <a:endParaRPr lang="fr-CA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CA" sz="10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...............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..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T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CA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....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TC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fr-CA" sz="1000" dirty="0" smtClean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AG</a:t>
            </a:r>
            <a:endParaRPr lang="fr-CA" sz="10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CA" sz="10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 </a:t>
            </a:r>
            <a:r>
              <a:rPr lang="en-CA" sz="9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900" dirty="0" smtClean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 smtClean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ATCGGTAGACTTAAGAGCTTTTGTCCTTGTGGATATTTT   4718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........................................   4302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AGTGGA</a:t>
            </a:r>
            <a:r>
              <a:rPr lang="en-CA" sz="900" dirty="0">
                <a:highlight>
                  <a:srgbClr val="C0C0C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CACATCAGTCTCAATACTGT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TTTAC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4758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.....................................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4305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C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CT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CA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GC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   4798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TC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CT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.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CA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TT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G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G   4344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TTAAGGCAGGCA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A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TTA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   4838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ATTCCTTT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AGG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   4384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GCA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ACTCTCAG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C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4878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    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T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TTC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G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CTTGAATTC.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C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4423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 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1    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CA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GACT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GT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AGA</a:t>
            </a:r>
            <a:r>
              <a:rPr lang="en-CA" sz="900" dirty="0">
                <a:solidFill>
                  <a:srgbClr val="FFFFFF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4918</a:t>
            </a:r>
            <a:endParaRPr lang="fr-CA" sz="9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0"/>
              </a:spcAft>
            </a:pP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DNAMAN5</a:t>
            </a:r>
            <a:r>
              <a:rPr lang="en-CA" sz="900" dirty="0">
                <a:solidFill>
                  <a:srgbClr val="FFFFFF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 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TCA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GACT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GAT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TGTC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CA" sz="900" dirty="0">
                <a:solidFill>
                  <a:srgbClr val="FFFFFF"/>
                </a:solidFill>
                <a:highlight>
                  <a:srgbClr val="000000"/>
                </a:highlight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TGAGA</a:t>
            </a:r>
            <a:r>
              <a:rPr lang="en-CA" sz="900" dirty="0">
                <a:solidFill>
                  <a:srgbClr val="FFFFFF"/>
                </a:solidFill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   </a:t>
            </a:r>
            <a:r>
              <a:rPr lang="en-CA" sz="900" dirty="0">
                <a:latin typeface="Courier New" panose="02070309020205020404" pitchFamily="49" charset="0"/>
                <a:ea typeface="Calibri" panose="020F0502020204030204" pitchFamily="34" charset="0"/>
                <a:cs typeface="Times New Roman" panose="02020603050405020304" pitchFamily="18" charset="0"/>
              </a:rPr>
              <a:t>4463</a:t>
            </a:r>
            <a:endParaRPr lang="fr-CA" sz="9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38" name="ZoneTexte 37"/>
          <p:cNvSpPr txBox="1"/>
          <p:nvPr/>
        </p:nvSpPr>
        <p:spPr>
          <a:xfrm>
            <a:off x="683568" y="2302417"/>
            <a:ext cx="12777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fr-CA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CA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piens</a:t>
            </a:r>
          </a:p>
          <a:p>
            <a:r>
              <a:rPr lang="fr-CA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9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6" name="ZoneTexte 45"/>
          <p:cNvSpPr txBox="1"/>
          <p:nvPr/>
        </p:nvSpPr>
        <p:spPr>
          <a:xfrm>
            <a:off x="683568" y="2731793"/>
            <a:ext cx="12777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fr-CA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CA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piens</a:t>
            </a:r>
          </a:p>
          <a:p>
            <a:r>
              <a:rPr lang="fr-CA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9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ZoneTexte 46"/>
          <p:cNvSpPr txBox="1"/>
          <p:nvPr/>
        </p:nvSpPr>
        <p:spPr>
          <a:xfrm>
            <a:off x="683568" y="3182754"/>
            <a:ext cx="1277787" cy="369332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fr-CA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H. </a:t>
            </a:r>
            <a:r>
              <a:rPr lang="fr-CA" sz="900" b="1" i="1" dirty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fr-CA" sz="9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apiens</a:t>
            </a:r>
          </a:p>
          <a:p>
            <a:r>
              <a:rPr lang="fr-CA" sz="900" b="1" i="1" dirty="0">
                <a:latin typeface="Arial" panose="020B0604020202020204" pitchFamily="34" charset="0"/>
                <a:cs typeface="Arial" panose="020B0604020202020204" pitchFamily="34" charset="0"/>
              </a:rPr>
              <a:t> I. </a:t>
            </a:r>
            <a:r>
              <a:rPr lang="fr-CA" sz="900" b="1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idecemlineatus</a:t>
            </a:r>
            <a:endParaRPr lang="fr-CA" sz="900" b="1" i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899592" y="3552086"/>
            <a:ext cx="5112567" cy="296581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CA"/>
          </a:p>
        </p:txBody>
      </p:sp>
      <p:cxnSp>
        <p:nvCxnSpPr>
          <p:cNvPr id="5" name="Connecteur droit 4"/>
          <p:cNvCxnSpPr/>
          <p:nvPr/>
        </p:nvCxnSpPr>
        <p:spPr>
          <a:xfrm>
            <a:off x="5940152" y="2656439"/>
            <a:ext cx="576064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Image 5"/>
          <p:cNvPicPr preferRelativeResize="0"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1995177" y="3107468"/>
            <a:ext cx="1152000" cy="3048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228191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6</TotalTime>
  <Words>113</Words>
  <Application>Microsoft Office PowerPoint</Application>
  <PresentationFormat>全屏显示(4:3)</PresentationFormat>
  <Paragraphs>38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Thème Office</vt:lpstr>
      <vt:lpstr>PowerPoint 演示文稿</vt:lpstr>
    </vt:vector>
  </TitlesOfParts>
  <Company>universtié de monc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usager</dc:creator>
  <cp:lastModifiedBy>谢珊珊</cp:lastModifiedBy>
  <cp:revision>79</cp:revision>
  <cp:lastPrinted>2016-03-24T11:48:48Z</cp:lastPrinted>
  <dcterms:created xsi:type="dcterms:W3CDTF">2012-07-24T13:52:45Z</dcterms:created>
  <dcterms:modified xsi:type="dcterms:W3CDTF">2016-04-17T13:02:03Z</dcterms:modified>
</cp:coreProperties>
</file>